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0972800" cy="5943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276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iuddin, Sayed Golam" userId="5c5f2d06-5da7-4463-8de7-92cf1264e307" providerId="ADAL" clId="{6B7136DD-F533-4A59-AE5C-E69811A945F0}"/>
    <pc:docChg chg="custSel modSld">
      <pc:chgData name="Mohiuddin, Sayed Golam" userId="5c5f2d06-5da7-4463-8de7-92cf1264e307" providerId="ADAL" clId="{6B7136DD-F533-4A59-AE5C-E69811A945F0}" dt="2023-08-03T22:35:59.609" v="71" actId="20577"/>
      <pc:docMkLst>
        <pc:docMk/>
      </pc:docMkLst>
      <pc:sldChg chg="addSp delSp modSp mod delAnim">
        <pc:chgData name="Mohiuddin, Sayed Golam" userId="5c5f2d06-5da7-4463-8de7-92cf1264e307" providerId="ADAL" clId="{6B7136DD-F533-4A59-AE5C-E69811A945F0}" dt="2023-08-03T22:35:59.609" v="71" actId="20577"/>
        <pc:sldMkLst>
          <pc:docMk/>
          <pc:sldMk cId="3094627663" sldId="256"/>
        </pc:sldMkLst>
        <pc:spChg chg="del">
          <ac:chgData name="Mohiuddin, Sayed Golam" userId="5c5f2d06-5da7-4463-8de7-92cf1264e307" providerId="ADAL" clId="{6B7136DD-F533-4A59-AE5C-E69811A945F0}" dt="2023-08-03T22:26:37.811" v="0" actId="478"/>
          <ac:spMkLst>
            <pc:docMk/>
            <pc:sldMk cId="3094627663" sldId="256"/>
            <ac:spMk id="3" creationId="{11844445-2A08-4619-9BD2-5BA2187F4A90}"/>
          </ac:spMkLst>
        </pc:spChg>
        <pc:spChg chg="del">
          <ac:chgData name="Mohiuddin, Sayed Golam" userId="5c5f2d06-5da7-4463-8de7-92cf1264e307" providerId="ADAL" clId="{6B7136DD-F533-4A59-AE5C-E69811A945F0}" dt="2023-08-03T22:26:37.811" v="0" actId="478"/>
          <ac:spMkLst>
            <pc:docMk/>
            <pc:sldMk cId="3094627663" sldId="256"/>
            <ac:spMk id="8" creationId="{069C52ED-490B-47D2-8D49-18450E764564}"/>
          </ac:spMkLst>
        </pc:spChg>
        <pc:spChg chg="del">
          <ac:chgData name="Mohiuddin, Sayed Golam" userId="5c5f2d06-5da7-4463-8de7-92cf1264e307" providerId="ADAL" clId="{6B7136DD-F533-4A59-AE5C-E69811A945F0}" dt="2023-08-03T22:26:37.811" v="0" actId="478"/>
          <ac:spMkLst>
            <pc:docMk/>
            <pc:sldMk cId="3094627663" sldId="256"/>
            <ac:spMk id="9" creationId="{2965E1A5-C5A4-4E60-9AA8-797162D54E5D}"/>
          </ac:spMkLst>
        </pc:spChg>
        <pc:spChg chg="mod">
          <ac:chgData name="Mohiuddin, Sayed Golam" userId="5c5f2d06-5da7-4463-8de7-92cf1264e307" providerId="ADAL" clId="{6B7136DD-F533-4A59-AE5C-E69811A945F0}" dt="2023-08-03T22:28:45.884" v="25" actId="1076"/>
          <ac:spMkLst>
            <pc:docMk/>
            <pc:sldMk cId="3094627663" sldId="256"/>
            <ac:spMk id="10" creationId="{89D1AAB6-0501-4C78-BA23-4573802B0CE5}"/>
          </ac:spMkLst>
        </pc:spChg>
        <pc:spChg chg="mod">
          <ac:chgData name="Mohiuddin, Sayed Golam" userId="5c5f2d06-5da7-4463-8de7-92cf1264e307" providerId="ADAL" clId="{6B7136DD-F533-4A59-AE5C-E69811A945F0}" dt="2023-08-03T22:28:45.884" v="25" actId="1076"/>
          <ac:spMkLst>
            <pc:docMk/>
            <pc:sldMk cId="3094627663" sldId="256"/>
            <ac:spMk id="11" creationId="{2B8653E6-4388-4353-8CA9-6F92F435C710}"/>
          </ac:spMkLst>
        </pc:spChg>
        <pc:spChg chg="del">
          <ac:chgData name="Mohiuddin, Sayed Golam" userId="5c5f2d06-5da7-4463-8de7-92cf1264e307" providerId="ADAL" clId="{6B7136DD-F533-4A59-AE5C-E69811A945F0}" dt="2023-08-03T22:26:37.811" v="0" actId="478"/>
          <ac:spMkLst>
            <pc:docMk/>
            <pc:sldMk cId="3094627663" sldId="256"/>
            <ac:spMk id="12" creationId="{3D28854F-15C3-436E-8FD8-46310D573967}"/>
          </ac:spMkLst>
        </pc:spChg>
        <pc:spChg chg="mod">
          <ac:chgData name="Mohiuddin, Sayed Golam" userId="5c5f2d06-5da7-4463-8de7-92cf1264e307" providerId="ADAL" clId="{6B7136DD-F533-4A59-AE5C-E69811A945F0}" dt="2023-08-03T22:28:45.884" v="25" actId="1076"/>
          <ac:spMkLst>
            <pc:docMk/>
            <pc:sldMk cId="3094627663" sldId="256"/>
            <ac:spMk id="13" creationId="{B5C0231A-CFA7-4416-ACF2-A01657EE5CDE}"/>
          </ac:spMkLst>
        </pc:spChg>
        <pc:spChg chg="mod">
          <ac:chgData name="Mohiuddin, Sayed Golam" userId="5c5f2d06-5da7-4463-8de7-92cf1264e307" providerId="ADAL" clId="{6B7136DD-F533-4A59-AE5C-E69811A945F0}" dt="2023-08-03T22:28:45.884" v="25" actId="1076"/>
          <ac:spMkLst>
            <pc:docMk/>
            <pc:sldMk cId="3094627663" sldId="256"/>
            <ac:spMk id="14" creationId="{5984CD19-EB02-47E6-ACDB-690FF7F1268A}"/>
          </ac:spMkLst>
        </pc:spChg>
        <pc:spChg chg="add mod">
          <ac:chgData name="Mohiuddin, Sayed Golam" userId="5c5f2d06-5da7-4463-8de7-92cf1264e307" providerId="ADAL" clId="{6B7136DD-F533-4A59-AE5C-E69811A945F0}" dt="2023-08-03T22:35:59.609" v="71" actId="20577"/>
          <ac:spMkLst>
            <pc:docMk/>
            <pc:sldMk cId="3094627663" sldId="256"/>
            <ac:spMk id="15" creationId="{A3DC52D5-4930-4350-88C9-FF3A8EE3058C}"/>
          </ac:spMkLst>
        </pc:spChg>
        <pc:picChg chg="mod">
          <ac:chgData name="Mohiuddin, Sayed Golam" userId="5c5f2d06-5da7-4463-8de7-92cf1264e307" providerId="ADAL" clId="{6B7136DD-F533-4A59-AE5C-E69811A945F0}" dt="2023-08-03T22:28:45.884" v="25" actId="1076"/>
          <ac:picMkLst>
            <pc:docMk/>
            <pc:sldMk cId="3094627663" sldId="256"/>
            <ac:picMk id="2" creationId="{D5A1A32A-9F3D-4452-A5E3-A4E849071F3D}"/>
          </ac:picMkLst>
        </pc:picChg>
        <pc:picChg chg="del">
          <ac:chgData name="Mohiuddin, Sayed Golam" userId="5c5f2d06-5da7-4463-8de7-92cf1264e307" providerId="ADAL" clId="{6B7136DD-F533-4A59-AE5C-E69811A945F0}" dt="2023-08-03T22:26:37.811" v="0" actId="478"/>
          <ac:picMkLst>
            <pc:docMk/>
            <pc:sldMk cId="3094627663" sldId="256"/>
            <ac:picMk id="4" creationId="{DD494BB7-BF3B-4E5D-9F55-1F5A42CE5C9A}"/>
          </ac:picMkLst>
        </pc:picChg>
        <pc:picChg chg="del">
          <ac:chgData name="Mohiuddin, Sayed Golam" userId="5c5f2d06-5da7-4463-8de7-92cf1264e307" providerId="ADAL" clId="{6B7136DD-F533-4A59-AE5C-E69811A945F0}" dt="2023-08-03T22:26:37.811" v="0" actId="478"/>
          <ac:picMkLst>
            <pc:docMk/>
            <pc:sldMk cId="3094627663" sldId="256"/>
            <ac:picMk id="5" creationId="{8476CE1E-7056-4238-A1C7-802F48FD0F53}"/>
          </ac:picMkLst>
        </pc:picChg>
        <pc:picChg chg="mod">
          <ac:chgData name="Mohiuddin, Sayed Golam" userId="5c5f2d06-5da7-4463-8de7-92cf1264e307" providerId="ADAL" clId="{6B7136DD-F533-4A59-AE5C-E69811A945F0}" dt="2023-08-03T22:28:45.884" v="25" actId="1076"/>
          <ac:picMkLst>
            <pc:docMk/>
            <pc:sldMk cId="3094627663" sldId="256"/>
            <ac:picMk id="7" creationId="{51BEC443-E9EC-4B0E-B067-629540807CB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972715"/>
            <a:ext cx="8229600" cy="2069253"/>
          </a:xfrm>
        </p:spPr>
        <p:txBody>
          <a:bodyPr anchor="b"/>
          <a:lstStyle>
            <a:lvl1pPr algn="ctr">
              <a:defRPr sz="5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121766"/>
            <a:ext cx="8229600" cy="1434994"/>
          </a:xfrm>
        </p:spPr>
        <p:txBody>
          <a:bodyPr/>
          <a:lstStyle>
            <a:lvl1pPr marL="0" indent="0" algn="ctr">
              <a:buNone/>
              <a:defRPr sz="2080"/>
            </a:lvl1pPr>
            <a:lvl2pPr marL="396255" indent="0" algn="ctr">
              <a:buNone/>
              <a:defRPr sz="1733"/>
            </a:lvl2pPr>
            <a:lvl3pPr marL="792510" indent="0" algn="ctr">
              <a:buNone/>
              <a:defRPr sz="1560"/>
            </a:lvl3pPr>
            <a:lvl4pPr marL="1188766" indent="0" algn="ctr">
              <a:buNone/>
              <a:defRPr sz="1387"/>
            </a:lvl4pPr>
            <a:lvl5pPr marL="1585021" indent="0" algn="ctr">
              <a:buNone/>
              <a:defRPr sz="1387"/>
            </a:lvl5pPr>
            <a:lvl6pPr marL="1981276" indent="0" algn="ctr">
              <a:buNone/>
              <a:defRPr sz="1387"/>
            </a:lvl6pPr>
            <a:lvl7pPr marL="2377531" indent="0" algn="ctr">
              <a:buNone/>
              <a:defRPr sz="1387"/>
            </a:lvl7pPr>
            <a:lvl8pPr marL="2773787" indent="0" algn="ctr">
              <a:buNone/>
              <a:defRPr sz="1387"/>
            </a:lvl8pPr>
            <a:lvl9pPr marL="3170042" indent="0" algn="ctr">
              <a:buNone/>
              <a:defRPr sz="138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140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699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0" y="316442"/>
            <a:ext cx="2366010" cy="503692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0" y="316442"/>
            <a:ext cx="6960870" cy="503692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230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050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5" y="1481773"/>
            <a:ext cx="9464040" cy="2472372"/>
          </a:xfrm>
        </p:spPr>
        <p:txBody>
          <a:bodyPr anchor="b"/>
          <a:lstStyle>
            <a:lvl1pPr>
              <a:defRPr sz="5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5" y="3977535"/>
            <a:ext cx="9464040" cy="1300162"/>
          </a:xfrm>
        </p:spPr>
        <p:txBody>
          <a:bodyPr/>
          <a:lstStyle>
            <a:lvl1pPr marL="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1pPr>
            <a:lvl2pPr marL="396255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2pPr>
            <a:lvl3pPr marL="79251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3pPr>
            <a:lvl4pPr marL="1188766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4pPr>
            <a:lvl5pPr marL="1585021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5pPr>
            <a:lvl6pPr marL="1981276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6pPr>
            <a:lvl7pPr marL="2377531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7pPr>
            <a:lvl8pPr marL="2773787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8pPr>
            <a:lvl9pPr marL="3170042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144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1582208"/>
            <a:ext cx="4663440" cy="3771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1582208"/>
            <a:ext cx="4663440" cy="3771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978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316442"/>
            <a:ext cx="9464040" cy="11488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1457008"/>
            <a:ext cx="4642008" cy="714057"/>
          </a:xfrm>
        </p:spPr>
        <p:txBody>
          <a:bodyPr anchor="b"/>
          <a:lstStyle>
            <a:lvl1pPr marL="0" indent="0">
              <a:buNone/>
              <a:defRPr sz="2080" b="1"/>
            </a:lvl1pPr>
            <a:lvl2pPr marL="396255" indent="0">
              <a:buNone/>
              <a:defRPr sz="1733" b="1"/>
            </a:lvl2pPr>
            <a:lvl3pPr marL="792510" indent="0">
              <a:buNone/>
              <a:defRPr sz="1560" b="1"/>
            </a:lvl3pPr>
            <a:lvl4pPr marL="1188766" indent="0">
              <a:buNone/>
              <a:defRPr sz="1387" b="1"/>
            </a:lvl4pPr>
            <a:lvl5pPr marL="1585021" indent="0">
              <a:buNone/>
              <a:defRPr sz="1387" b="1"/>
            </a:lvl5pPr>
            <a:lvl6pPr marL="1981276" indent="0">
              <a:buNone/>
              <a:defRPr sz="1387" b="1"/>
            </a:lvl6pPr>
            <a:lvl7pPr marL="2377531" indent="0">
              <a:buNone/>
              <a:defRPr sz="1387" b="1"/>
            </a:lvl7pPr>
            <a:lvl8pPr marL="2773787" indent="0">
              <a:buNone/>
              <a:defRPr sz="1387" b="1"/>
            </a:lvl8pPr>
            <a:lvl9pPr marL="3170042" indent="0">
              <a:buNone/>
              <a:defRPr sz="13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2171065"/>
            <a:ext cx="4642008" cy="3193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0" y="1457008"/>
            <a:ext cx="4664869" cy="714057"/>
          </a:xfrm>
        </p:spPr>
        <p:txBody>
          <a:bodyPr anchor="b"/>
          <a:lstStyle>
            <a:lvl1pPr marL="0" indent="0">
              <a:buNone/>
              <a:defRPr sz="2080" b="1"/>
            </a:lvl1pPr>
            <a:lvl2pPr marL="396255" indent="0">
              <a:buNone/>
              <a:defRPr sz="1733" b="1"/>
            </a:lvl2pPr>
            <a:lvl3pPr marL="792510" indent="0">
              <a:buNone/>
              <a:defRPr sz="1560" b="1"/>
            </a:lvl3pPr>
            <a:lvl4pPr marL="1188766" indent="0">
              <a:buNone/>
              <a:defRPr sz="1387" b="1"/>
            </a:lvl4pPr>
            <a:lvl5pPr marL="1585021" indent="0">
              <a:buNone/>
              <a:defRPr sz="1387" b="1"/>
            </a:lvl5pPr>
            <a:lvl6pPr marL="1981276" indent="0">
              <a:buNone/>
              <a:defRPr sz="1387" b="1"/>
            </a:lvl6pPr>
            <a:lvl7pPr marL="2377531" indent="0">
              <a:buNone/>
              <a:defRPr sz="1387" b="1"/>
            </a:lvl7pPr>
            <a:lvl8pPr marL="2773787" indent="0">
              <a:buNone/>
              <a:defRPr sz="1387" b="1"/>
            </a:lvl8pPr>
            <a:lvl9pPr marL="3170042" indent="0">
              <a:buNone/>
              <a:defRPr sz="13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0" y="2171065"/>
            <a:ext cx="4664869" cy="3193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956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03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41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96240"/>
            <a:ext cx="3539013" cy="1386840"/>
          </a:xfrm>
        </p:spPr>
        <p:txBody>
          <a:bodyPr anchor="b"/>
          <a:lstStyle>
            <a:lvl1pPr>
              <a:defRPr sz="27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855769"/>
            <a:ext cx="5554980" cy="4223808"/>
          </a:xfrm>
        </p:spPr>
        <p:txBody>
          <a:bodyPr/>
          <a:lstStyle>
            <a:lvl1pPr>
              <a:defRPr sz="2773"/>
            </a:lvl1pPr>
            <a:lvl2pPr>
              <a:defRPr sz="2427"/>
            </a:lvl2pPr>
            <a:lvl3pPr>
              <a:defRPr sz="208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783080"/>
            <a:ext cx="3539013" cy="3303376"/>
          </a:xfrm>
        </p:spPr>
        <p:txBody>
          <a:bodyPr/>
          <a:lstStyle>
            <a:lvl1pPr marL="0" indent="0">
              <a:buNone/>
              <a:defRPr sz="1387"/>
            </a:lvl1pPr>
            <a:lvl2pPr marL="396255" indent="0">
              <a:buNone/>
              <a:defRPr sz="1213"/>
            </a:lvl2pPr>
            <a:lvl3pPr marL="792510" indent="0">
              <a:buNone/>
              <a:defRPr sz="1040"/>
            </a:lvl3pPr>
            <a:lvl4pPr marL="1188766" indent="0">
              <a:buNone/>
              <a:defRPr sz="867"/>
            </a:lvl4pPr>
            <a:lvl5pPr marL="1585021" indent="0">
              <a:buNone/>
              <a:defRPr sz="867"/>
            </a:lvl5pPr>
            <a:lvl6pPr marL="1981276" indent="0">
              <a:buNone/>
              <a:defRPr sz="867"/>
            </a:lvl6pPr>
            <a:lvl7pPr marL="2377531" indent="0">
              <a:buNone/>
              <a:defRPr sz="867"/>
            </a:lvl7pPr>
            <a:lvl8pPr marL="2773787" indent="0">
              <a:buNone/>
              <a:defRPr sz="867"/>
            </a:lvl8pPr>
            <a:lvl9pPr marL="3170042" indent="0">
              <a:buNone/>
              <a:defRPr sz="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77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96240"/>
            <a:ext cx="3539013" cy="1386840"/>
          </a:xfrm>
        </p:spPr>
        <p:txBody>
          <a:bodyPr anchor="b"/>
          <a:lstStyle>
            <a:lvl1pPr>
              <a:defRPr sz="27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855769"/>
            <a:ext cx="5554980" cy="4223808"/>
          </a:xfrm>
        </p:spPr>
        <p:txBody>
          <a:bodyPr anchor="t"/>
          <a:lstStyle>
            <a:lvl1pPr marL="0" indent="0">
              <a:buNone/>
              <a:defRPr sz="2773"/>
            </a:lvl1pPr>
            <a:lvl2pPr marL="396255" indent="0">
              <a:buNone/>
              <a:defRPr sz="2427"/>
            </a:lvl2pPr>
            <a:lvl3pPr marL="792510" indent="0">
              <a:buNone/>
              <a:defRPr sz="2080"/>
            </a:lvl3pPr>
            <a:lvl4pPr marL="1188766" indent="0">
              <a:buNone/>
              <a:defRPr sz="1733"/>
            </a:lvl4pPr>
            <a:lvl5pPr marL="1585021" indent="0">
              <a:buNone/>
              <a:defRPr sz="1733"/>
            </a:lvl5pPr>
            <a:lvl6pPr marL="1981276" indent="0">
              <a:buNone/>
              <a:defRPr sz="1733"/>
            </a:lvl6pPr>
            <a:lvl7pPr marL="2377531" indent="0">
              <a:buNone/>
              <a:defRPr sz="1733"/>
            </a:lvl7pPr>
            <a:lvl8pPr marL="2773787" indent="0">
              <a:buNone/>
              <a:defRPr sz="1733"/>
            </a:lvl8pPr>
            <a:lvl9pPr marL="3170042" indent="0">
              <a:buNone/>
              <a:defRPr sz="17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783080"/>
            <a:ext cx="3539013" cy="3303376"/>
          </a:xfrm>
        </p:spPr>
        <p:txBody>
          <a:bodyPr/>
          <a:lstStyle>
            <a:lvl1pPr marL="0" indent="0">
              <a:buNone/>
              <a:defRPr sz="1387"/>
            </a:lvl1pPr>
            <a:lvl2pPr marL="396255" indent="0">
              <a:buNone/>
              <a:defRPr sz="1213"/>
            </a:lvl2pPr>
            <a:lvl3pPr marL="792510" indent="0">
              <a:buNone/>
              <a:defRPr sz="1040"/>
            </a:lvl3pPr>
            <a:lvl4pPr marL="1188766" indent="0">
              <a:buNone/>
              <a:defRPr sz="867"/>
            </a:lvl4pPr>
            <a:lvl5pPr marL="1585021" indent="0">
              <a:buNone/>
              <a:defRPr sz="867"/>
            </a:lvl5pPr>
            <a:lvl6pPr marL="1981276" indent="0">
              <a:buNone/>
              <a:defRPr sz="867"/>
            </a:lvl6pPr>
            <a:lvl7pPr marL="2377531" indent="0">
              <a:buNone/>
              <a:defRPr sz="867"/>
            </a:lvl7pPr>
            <a:lvl8pPr marL="2773787" indent="0">
              <a:buNone/>
              <a:defRPr sz="867"/>
            </a:lvl8pPr>
            <a:lvl9pPr marL="3170042" indent="0">
              <a:buNone/>
              <a:defRPr sz="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472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316442"/>
            <a:ext cx="9464040" cy="1148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1582208"/>
            <a:ext cx="9464040" cy="37711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5508837"/>
            <a:ext cx="246888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5508837"/>
            <a:ext cx="370332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5508837"/>
            <a:ext cx="246888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0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92510" rtl="0" eaLnBrk="1" latinLnBrk="0" hangingPunct="1">
        <a:lnSpc>
          <a:spcPct val="90000"/>
        </a:lnSpc>
        <a:spcBef>
          <a:spcPct val="0"/>
        </a:spcBef>
        <a:buNone/>
        <a:defRPr sz="38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8128" indent="-198128" algn="l" defTabSz="79251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2427" kern="1200">
          <a:solidFill>
            <a:schemeClr val="tx1"/>
          </a:solidFill>
          <a:latin typeface="+mn-lt"/>
          <a:ea typeface="+mn-ea"/>
          <a:cs typeface="+mn-cs"/>
        </a:defRPr>
      </a:lvl1pPr>
      <a:lvl2pPr marL="594383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80" kern="1200">
          <a:solidFill>
            <a:schemeClr val="tx1"/>
          </a:solidFill>
          <a:latin typeface="+mn-lt"/>
          <a:ea typeface="+mn-ea"/>
          <a:cs typeface="+mn-cs"/>
        </a:defRPr>
      </a:lvl2pPr>
      <a:lvl3pPr marL="990638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3pPr>
      <a:lvl4pPr marL="1386893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4pPr>
      <a:lvl5pPr marL="1783149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5pPr>
      <a:lvl6pPr marL="2179404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6pPr>
      <a:lvl7pPr marL="2575659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7pPr>
      <a:lvl8pPr marL="2971914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8pPr>
      <a:lvl9pPr marL="3368170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1pPr>
      <a:lvl2pPr marL="396255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2pPr>
      <a:lvl3pPr marL="792510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66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4pPr>
      <a:lvl5pPr marL="1585021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5pPr>
      <a:lvl6pPr marL="1981276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6pPr>
      <a:lvl7pPr marL="2377531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7pPr>
      <a:lvl8pPr marL="2773787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8pPr>
      <a:lvl9pPr marL="3170042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A01_tracked_1">
            <a:hlinkClick r:id="" action="ppaction://media"/>
            <a:extLst>
              <a:ext uri="{FF2B5EF4-FFF2-40B4-BE49-F238E27FC236}">
                <a16:creationId xmlns:a16="http://schemas.microsoft.com/office/drawing/2014/main" id="{51BEC443-E9EC-4B0E-B067-629540807CB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749754" y="536431"/>
            <a:ext cx="4685728" cy="366911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9D1AAB6-0501-4C78-BA23-4573802B0CE5}"/>
              </a:ext>
            </a:extLst>
          </p:cNvPr>
          <p:cNvSpPr txBox="1"/>
          <p:nvPr/>
        </p:nvSpPr>
        <p:spPr>
          <a:xfrm>
            <a:off x="6760375" y="124819"/>
            <a:ext cx="3040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tracked)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B8653E6-4388-4353-8CA9-6F92F435C710}"/>
              </a:ext>
            </a:extLst>
          </p:cNvPr>
          <p:cNvSpPr txBox="1"/>
          <p:nvPr/>
        </p:nvSpPr>
        <p:spPr>
          <a:xfrm>
            <a:off x="1228531" y="124819"/>
            <a:ext cx="3296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untracked) </a:t>
            </a:r>
          </a:p>
        </p:txBody>
      </p:sp>
      <p:pic>
        <p:nvPicPr>
          <p:cNvPr id="2" name="pa1_22fps">
            <a:hlinkClick r:id="" action="ppaction://media"/>
            <a:extLst>
              <a:ext uri="{FF2B5EF4-FFF2-40B4-BE49-F238E27FC236}">
                <a16:creationId xmlns:a16="http://schemas.microsoft.com/office/drawing/2014/main" id="{D5A1A32A-9F3D-4452-A5E3-A4E849071F3D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44895" y="670206"/>
            <a:ext cx="4310359" cy="340156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5C0231A-CFA7-4416-ACF2-A01657EE5CDE}"/>
              </a:ext>
            </a:extLst>
          </p:cNvPr>
          <p:cNvSpPr txBox="1"/>
          <p:nvPr/>
        </p:nvSpPr>
        <p:spPr>
          <a:xfrm>
            <a:off x="136585" y="12533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984CD19-EB02-47E6-ACDB-690FF7F1268A}"/>
              </a:ext>
            </a:extLst>
          </p:cNvPr>
          <p:cNvSpPr txBox="1"/>
          <p:nvPr/>
        </p:nvSpPr>
        <p:spPr>
          <a:xfrm>
            <a:off x="5278723" y="78652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DC52D5-4930-4350-88C9-FF3A8EE3058C}"/>
              </a:ext>
            </a:extLst>
          </p:cNvPr>
          <p:cNvSpPr txBox="1"/>
          <p:nvPr/>
        </p:nvSpPr>
        <p:spPr>
          <a:xfrm>
            <a:off x="561524" y="4381605"/>
            <a:ext cx="979058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ovie S2. Representative movies for bacterial strains. (c-d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Untracked and tracke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P. aeruginos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wild-type (WT) cells, respectively. Single-cell tracking in panel “d”, highlighted in red circles, is performed using a MATLAB code. The tracked video (d) is ~8 times slower than its original version (panel c).   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46276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9546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86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80</Words>
  <Application>Microsoft Office PowerPoint</Application>
  <PresentationFormat>Custom</PresentationFormat>
  <Paragraphs>5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iuddin, Sayed Golam</dc:creator>
  <cp:lastModifiedBy>Sayed Golam Mohiuddin</cp:lastModifiedBy>
  <cp:revision>23</cp:revision>
  <dcterms:created xsi:type="dcterms:W3CDTF">2023-07-18T23:55:47Z</dcterms:created>
  <dcterms:modified xsi:type="dcterms:W3CDTF">2024-10-17T21:03:14Z</dcterms:modified>
</cp:coreProperties>
</file>